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5AAEF-8B09-45B9-AE6A-B9D1D0B41E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0EF25-A0F0-4C64-9772-B8F316A0EB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BDC26-6FBC-49FD-860A-431BAA49CB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DF7B4-C6E3-40EC-9D98-B9BF52D1CA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D3DF8-08AC-42BF-8E14-56C4E7BCBA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668C1-69F8-4EDD-9AA3-25633F5F55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78793-06F3-462F-B866-C5D6E0740E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9B3C4-FD3E-4311-B4C5-7C5F7E493C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13EE5-697C-4130-BFAC-553F6EB78E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50E86-CD5B-479F-A970-13F51551DA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68BFD-3C29-4114-9AAF-FEFE36373C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BEA50-4D60-4974-804E-172207AECF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552AF0-41BB-498E-8D80-04D14966814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1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02160" y="0"/>
            <a:ext cx="6775920" cy="6578640"/>
            <a:chOff x="902160" y="0"/>
            <a:chExt cx="6775920" cy="6578640"/>
          </a:xfrm>
        </p:grpSpPr>
        <p:sp>
          <p:nvSpPr>
            <p:cNvPr id="42" name=""/>
            <p:cNvSpPr/>
            <p:nvPr/>
          </p:nvSpPr>
          <p:spPr>
            <a:xfrm>
              <a:off x="948240" y="21744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902160" y="248436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902160" y="499104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C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797080" y="0"/>
              <a:ext cx="58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PK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724360" y="624528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43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724360" y="5614920"/>
              <a:ext cx="792000" cy="23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4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64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4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593600" y="5411880"/>
              <a:ext cx="9885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ectopic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216040" y="622476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act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8000000">
              <a:off x="6067800" y="4527000"/>
              <a:ext cx="181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ORBS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8000000">
              <a:off x="6428160" y="4682520"/>
              <a:ext cx="152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C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Bild 4" descr=""/>
            <p:cNvPicPr/>
            <p:nvPr/>
          </p:nvPicPr>
          <p:blipFill>
            <a:blip r:embed="rId1"/>
            <a:srcRect l="22853" t="38111" r="65840" b="8285"/>
            <a:stretch/>
          </p:blipFill>
          <p:spPr>
            <a:xfrm>
              <a:off x="6373440" y="5411880"/>
              <a:ext cx="749520" cy="116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" descr=""/>
            <p:cNvPicPr/>
            <p:nvPr/>
          </p:nvPicPr>
          <p:blipFill>
            <a:blip r:embed="rId2"/>
            <a:stretch/>
          </p:blipFill>
          <p:spPr>
            <a:xfrm>
              <a:off x="4571640" y="2603520"/>
              <a:ext cx="3097440" cy="2230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"/>
            <p:cNvSpPr/>
            <p:nvPr/>
          </p:nvSpPr>
          <p:spPr>
            <a:xfrm>
              <a:off x="2555640" y="6235560"/>
              <a:ext cx="79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43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555640" y="5603760"/>
              <a:ext cx="792360" cy="23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4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64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4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331280" y="5400720"/>
              <a:ext cx="9885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ectopic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953720" y="621360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act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8000000">
              <a:off x="2805480" y="4515840"/>
              <a:ext cx="181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ORBS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8000000">
              <a:off x="3165840" y="4671360"/>
              <a:ext cx="152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C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0" name="Bild 4" descr=""/>
            <p:cNvPicPr/>
            <p:nvPr/>
          </p:nvPicPr>
          <p:blipFill>
            <a:blip r:embed="rId3"/>
            <a:srcRect l="38633" t="38111" r="50060" b="8285"/>
            <a:stretch/>
          </p:blipFill>
          <p:spPr>
            <a:xfrm>
              <a:off x="3132000" y="5400720"/>
              <a:ext cx="752400" cy="116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"/>
            <p:cNvSpPr/>
            <p:nvPr/>
          </p:nvSpPr>
          <p:spPr>
            <a:xfrm>
              <a:off x="2475720" y="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PK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" descr=""/>
            <p:cNvPicPr/>
            <p:nvPr/>
          </p:nvPicPr>
          <p:blipFill>
            <a:blip r:embed="rId4"/>
            <a:stretch/>
          </p:blipFill>
          <p:spPr>
            <a:xfrm>
              <a:off x="1428480" y="2593800"/>
              <a:ext cx="3071880" cy="2230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" descr=""/>
            <p:cNvPicPr/>
            <p:nvPr/>
          </p:nvPicPr>
          <p:blipFill>
            <a:blip r:embed="rId5"/>
            <a:stretch/>
          </p:blipFill>
          <p:spPr>
            <a:xfrm>
              <a:off x="4571640" y="333360"/>
              <a:ext cx="3097440" cy="224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" descr=""/>
            <p:cNvPicPr/>
            <p:nvPr/>
          </p:nvPicPr>
          <p:blipFill>
            <a:blip r:embed="rId6"/>
            <a:stretch/>
          </p:blipFill>
          <p:spPr>
            <a:xfrm>
              <a:off x="1409400" y="316080"/>
              <a:ext cx="3090960" cy="22492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20T13:44:33Z</dcterms:created>
  <dc:creator>BACKSCH</dc:creator>
  <dc:description/>
  <dc:language>en-US</dc:language>
  <cp:lastModifiedBy>BACKSCH</cp:lastModifiedBy>
  <dcterms:modified xsi:type="dcterms:W3CDTF">2013-08-29T16:43:31Z</dcterms:modified>
  <cp:revision>25</cp:revision>
  <dc:subject/>
  <dc:title>Folie 1</dc:title>
</cp:coreProperties>
</file>